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4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06093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03559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50459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26912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77861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90246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62739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01114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90833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19982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51861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3D150-9AC4-4462-B8B8-686953BFBBFF}" type="datetimeFigureOut">
              <a:rPr lang="nl-NL" smtClean="0"/>
              <a:t>09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62B10-CB63-4FCC-8036-DFD85DC61B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11377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ep 4"/>
          <p:cNvGrpSpPr/>
          <p:nvPr/>
        </p:nvGrpSpPr>
        <p:grpSpPr>
          <a:xfrm>
            <a:off x="2997813" y="299367"/>
            <a:ext cx="6196374" cy="6382377"/>
            <a:chOff x="2630126" y="160258"/>
            <a:chExt cx="6196374" cy="6382377"/>
          </a:xfrm>
        </p:grpSpPr>
        <p:pic>
          <p:nvPicPr>
            <p:cNvPr id="4" name="EVHP_movie - kopie">
              <a:hlinkClick r:id="" action="ppaction://media"/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4"/>
            <a:stretch>
              <a:fillRect/>
            </a:stretch>
          </p:blipFill>
          <p:spPr>
            <a:xfrm>
              <a:off x="2630127" y="160258"/>
              <a:ext cx="6196373" cy="4812717"/>
            </a:xfrm>
            <a:prstGeom prst="rect">
              <a:avLst/>
            </a:prstGeom>
          </p:spPr>
        </p:pic>
        <p:sp>
          <p:nvSpPr>
            <p:cNvPr id="3" name="Rechthoek 2"/>
            <p:cNvSpPr/>
            <p:nvPr/>
          </p:nvSpPr>
          <p:spPr>
            <a:xfrm>
              <a:off x="2630126" y="4972975"/>
              <a:ext cx="6196373" cy="156966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200000"/>
                </a:lnSpc>
                <a:spcAft>
                  <a:spcPts val="800"/>
                </a:spcAft>
              </a:pPr>
              <a:r>
                <a:rPr lang="en-GB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Supplementary Video</a:t>
              </a:r>
              <a:r>
                <a:rPr lang="en-GB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. </a:t>
              </a: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Exemplary videos of contractile performance of PSH in Group </a:t>
              </a:r>
              <a:r>
                <a:rPr lang="en-US" sz="1200" dirty="0" smtClean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1 (left) </a:t>
              </a: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and Group </a:t>
              </a:r>
              <a:r>
                <a:rPr lang="en-US" sz="1200" dirty="0" smtClean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2</a:t>
              </a:r>
              <a:r>
                <a:rPr lang="en-GB" sz="1200" dirty="0" smtClean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 (right)</a:t>
              </a:r>
              <a:r>
                <a:rPr lang="en-GB" sz="1200" dirty="0" smtClean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GB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ontractility of the heart in Group 1 was scored 1 and contractile performance was judged insufficient for transplantation by transplant surgeons. Contractility of the heart in Group 2 was scored 4 and contractile performance was judged acceptable for transplantation.</a:t>
              </a:r>
              <a:endParaRPr lang="nl-NL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15819397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3</Words>
  <Application>Microsoft Office PowerPoint</Application>
  <PresentationFormat>Breedbeeld</PresentationFormat>
  <Paragraphs>1</Paragraphs>
  <Slides>1</Slides>
  <Notes>0</Notes>
  <HiddenSlides>0</HiddenSlides>
  <MMClips>1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Kantoorthema</vt:lpstr>
      <vt:lpstr>PowerPoint-presentatie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Jorik Amesz</dc:creator>
  <cp:lastModifiedBy>Jorik Amesz</cp:lastModifiedBy>
  <cp:revision>2</cp:revision>
  <dcterms:created xsi:type="dcterms:W3CDTF">2024-05-20T11:25:29Z</dcterms:created>
  <dcterms:modified xsi:type="dcterms:W3CDTF">2024-11-09T13:27:53Z</dcterms:modified>
</cp:coreProperties>
</file>